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760" r:id="rId2"/>
    <p:sldId id="261" r:id="rId3"/>
    <p:sldId id="758" r:id="rId4"/>
    <p:sldId id="759" r:id="rId5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nnis" initials="D" lastIdx="4" clrIdx="0">
    <p:extLst>
      <p:ext uri="{19B8F6BF-5375-455C-9EA6-DF929625EA0E}">
        <p15:presenceInfo xmlns:p15="http://schemas.microsoft.com/office/powerpoint/2012/main" userId="f672dbfe554dbb24" providerId="Windows Live"/>
      </p:ext>
    </p:extLst>
  </p:cmAuthor>
  <p:cmAuthor id="2" name="Jan ter Meulen" initials="JtM" lastIdx="6" clrIdx="1">
    <p:extLst>
      <p:ext uri="{19B8F6BF-5375-455C-9EA6-DF929625EA0E}">
        <p15:presenceInfo xmlns:p15="http://schemas.microsoft.com/office/powerpoint/2012/main" userId="13803f1482ba0a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721" autoAdjust="0"/>
    <p:restoredTop sz="94660"/>
  </p:normalViewPr>
  <p:slideViewPr>
    <p:cSldViewPr snapToGrid="0">
      <p:cViewPr varScale="1">
        <p:scale>
          <a:sx n="61" d="100"/>
          <a:sy n="61" d="100"/>
        </p:scale>
        <p:origin x="104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551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274576-0E26-497F-B7DF-2BD44A3332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1BE1A2-AB11-414E-8BD1-E74F928CD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C05637-17FA-4428-AD5E-863C727F3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DBC43F-2762-4292-BF66-8A06AE90A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F84269-82F7-4BB6-9FE8-80B563C6B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73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6C044-775F-44F2-B567-F71904D3A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0EB62C-55C7-4232-85C1-542040C870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E47154-5B9E-48D4-BC20-15436FD9E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11F5DA-3918-4C95-B274-E9717B2A0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832FC-74D2-464E-BE49-63F097578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12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7E72B0-4247-4894-B77A-3075BC1F80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B1C148-090C-4056-8405-FB8B7A5484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209FC9-8719-45E1-80A3-E36EFF5CA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23F42E-FFA2-4827-914D-22F572149F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5305A1-1617-40D0-8A7C-93C0112AD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077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85FB5-3AF9-46F3-84AA-6DECB0FA94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1CF961-330D-472C-B812-06CFD2A6E6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FF70D6-D414-491C-80E2-A977A9F76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202345-9485-4289-89C3-9D35FDF34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C3B77-30CA-4992-A35A-64A84932B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21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7C6273-5316-4701-8FFC-A60FBA9B8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2E962E-D11B-4E0C-9740-C288994A62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F5284-F085-4B99-9C4E-4DF030D9C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7EA8A-D0E7-44F7-A300-9CC0B8949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3EC526-C6CA-4126-81C0-696238E68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69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FD9FAC-2F58-47EF-8B32-1E9517FF32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88E949-CBC1-48AE-9DE5-047BF9397F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BE7BC5-96DB-454F-B60C-9C5F781EDF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A50B4A-5BD2-4722-94FD-3729882B4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1C1D68-45DF-4C40-BDDE-E5E292F361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68A11C-D9DF-44B2-8843-61C7611FE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560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DCCC3-B0CC-4FCD-8FF3-B9A6A1FCD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EFF777-D687-49A2-8413-470A942A24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9CA034-0E71-443E-B066-9FD892DA8D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9F0168-7869-41AA-B1DD-9658C36212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F44A14C-2FA1-4785-AFB2-699F19F07E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EB1B3A-83C4-4A31-BF54-0E2552EAA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04D626-648E-4FD2-98AF-AC1FC61D7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422194-A202-4570-B4C1-A7C0E00A4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603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CFA261-3BA2-4581-97B0-8AAC0973B1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4F2951-5FF4-49E3-8C02-0D187D41D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8D50B7-B52D-42BA-9740-2D1ABE6EF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584F65-9ECB-4B7C-9F4B-579CA44EB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447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399C45-26F2-4EDA-9360-4BC3E60B6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F6F33C-766B-48A0-890F-C332DC1EE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10C964-75F1-464D-A9E9-C3D3679B7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193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120068-7156-4DAE-9F3E-8A1BF0E38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BD75E3-88D5-4244-A8E6-C05E1FEA53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3BC13D-AE6B-45C0-BF84-B02E16558A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37B5A7-3B75-4891-9FE7-0987705DE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511E68-6CA6-478B-BED4-8E5F616B2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8CC645-909E-4AAE-ABFB-56128BBC2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898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AF02B-E282-4026-9560-1D7FC4862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8DA03F-7DF9-41E8-841D-96BCFA25D9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C140B8-1A2A-4DF4-BD4B-ED742CAF8B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DB4ABA-8F76-4990-93FB-9A912BCB3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0C0AE6-A01A-437E-B264-D9D58191D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03B5F2-71CE-4FAE-A040-A5D6AA340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25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87D7FA-BA5A-4925-BAF7-091D48683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3E40C3-BE7B-4E43-BCAB-B17BF68D21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06917B-2183-480E-8804-D2FEBCF256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ACDFB-AD51-4D0F-A45F-F713B08EA9B1}" type="datetimeFigureOut">
              <a:rPr lang="en-US" smtClean="0"/>
              <a:t>2/2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8C1567-7573-4C82-8BC8-5EEC89C849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72CF3A-C30E-4556-9918-567D3AB291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E499-F9CC-4BF7-B252-0A16DAEE87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142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emf"/><Relationship Id="rId5" Type="http://schemas.openxmlformats.org/officeDocument/2006/relationships/image" Target="../media/image2.emf"/><Relationship Id="rId10" Type="http://schemas.openxmlformats.org/officeDocument/2006/relationships/image" Target="../media/image5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3030CBE-09D6-4510-B3A9-E33FF26B9477}"/>
              </a:ext>
            </a:extLst>
          </p:cNvPr>
          <p:cNvGrpSpPr/>
          <p:nvPr/>
        </p:nvGrpSpPr>
        <p:grpSpPr>
          <a:xfrm>
            <a:off x="2373799" y="2116004"/>
            <a:ext cx="8733085" cy="4211771"/>
            <a:chOff x="2174421" y="2083681"/>
            <a:chExt cx="9364047" cy="4438894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76ECD44-08F4-4807-8FAB-01E6B0BFFA20}"/>
                </a:ext>
              </a:extLst>
            </p:cNvPr>
            <p:cNvSpPr txBox="1"/>
            <p:nvPr/>
          </p:nvSpPr>
          <p:spPr>
            <a:xfrm>
              <a:off x="2174421" y="2083681"/>
              <a:ext cx="991246" cy="30777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400" dirty="0"/>
                <a:t>GMT: 32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E6C0FA6-E647-42E1-BDCF-53EE130AFFDC}"/>
                </a:ext>
              </a:extLst>
            </p:cNvPr>
            <p:cNvSpPr txBox="1"/>
            <p:nvPr/>
          </p:nvSpPr>
          <p:spPr>
            <a:xfrm>
              <a:off x="2248532" y="4622217"/>
              <a:ext cx="1094657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400" dirty="0"/>
                <a:t>GMT: 38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43B3082-A37B-48B7-B48E-29F9E0624F0E}"/>
                </a:ext>
              </a:extLst>
            </p:cNvPr>
            <p:cNvSpPr txBox="1"/>
            <p:nvPr/>
          </p:nvSpPr>
          <p:spPr>
            <a:xfrm>
              <a:off x="5954648" y="2083681"/>
              <a:ext cx="1221917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400" dirty="0"/>
                <a:t>GMT: 1448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DE3F395-3F1B-4DA6-A10B-4AED9417AFA7}"/>
                </a:ext>
              </a:extLst>
            </p:cNvPr>
            <p:cNvSpPr txBox="1"/>
            <p:nvPr/>
          </p:nvSpPr>
          <p:spPr>
            <a:xfrm>
              <a:off x="6096000" y="4622218"/>
              <a:ext cx="132336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400" dirty="0"/>
                <a:t>GMT: 14263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0F597A0-92FE-4B03-978D-C0662739C984}"/>
                </a:ext>
              </a:extLst>
            </p:cNvPr>
            <p:cNvSpPr txBox="1"/>
            <p:nvPr/>
          </p:nvSpPr>
          <p:spPr>
            <a:xfrm>
              <a:off x="9946238" y="2111557"/>
              <a:ext cx="138383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400" dirty="0"/>
                <a:t>GMT: 57926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0AC23D7-25C0-4CB3-A44D-D7AC7B1075FF}"/>
                </a:ext>
              </a:extLst>
            </p:cNvPr>
            <p:cNvSpPr txBox="1"/>
            <p:nvPr/>
          </p:nvSpPr>
          <p:spPr>
            <a:xfrm>
              <a:off x="9946238" y="4622219"/>
              <a:ext cx="1545497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sz="1400" dirty="0"/>
                <a:t>GMT: 327680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EB747C4-C5CF-409A-AA27-6C9AFBC438C4}"/>
                </a:ext>
              </a:extLst>
            </p:cNvPr>
            <p:cNvSpPr txBox="1"/>
            <p:nvPr/>
          </p:nvSpPr>
          <p:spPr>
            <a:xfrm>
              <a:off x="10464885" y="6267978"/>
              <a:ext cx="1073583" cy="2545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*not fully diluted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5525D048-1DEC-4078-85CB-F2DD07443695}"/>
              </a:ext>
            </a:extLst>
          </p:cNvPr>
          <p:cNvSpPr txBox="1"/>
          <p:nvPr/>
        </p:nvSpPr>
        <p:spPr>
          <a:xfrm>
            <a:off x="407426" y="229232"/>
            <a:ext cx="109727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Suppl. Fig. 2a. M-cell targeting of RBD (RBD-C-CPE) increases IgG responses in NALF, BALF and serum </a:t>
            </a:r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/>
        </p:nvGraphicFramePr>
        <p:xfrm>
          <a:off x="308135" y="1806793"/>
          <a:ext cx="4004561" cy="2030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5420042" imgH="2747255" progId="Prism7.Document">
                  <p:embed/>
                </p:oleObj>
              </mc:Choice>
              <mc:Fallback>
                <p:oleObj name="Prism 7" r:id="rId2" imgW="5420042" imgH="2747255" progId="Prism7.Document">
                  <p:embed/>
                  <p:pic>
                    <p:nvPicPr>
                      <p:cNvPr id="9" name="Objekt 8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8135" y="1806793"/>
                        <a:ext cx="4004561" cy="20304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/>
        </p:nvGraphicFramePr>
        <p:xfrm>
          <a:off x="375895" y="4228636"/>
          <a:ext cx="3936801" cy="19960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5420042" imgH="2747255" progId="Prism7.Document">
                  <p:embed/>
                </p:oleObj>
              </mc:Choice>
              <mc:Fallback>
                <p:oleObj name="Prism 7" r:id="rId4" imgW="5420042" imgH="2747255" progId="Prism7.Document">
                  <p:embed/>
                  <p:pic>
                    <p:nvPicPr>
                      <p:cNvPr id="10" name="Objekt 9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75895" y="4228636"/>
                        <a:ext cx="3936801" cy="19960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/>
        </p:nvGraphicFramePr>
        <p:xfrm>
          <a:off x="4175313" y="4224469"/>
          <a:ext cx="3945020" cy="20002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5420042" imgH="2747255" progId="Prism7.Document">
                  <p:embed/>
                </p:oleObj>
              </mc:Choice>
              <mc:Fallback>
                <p:oleObj name="Prism 7" r:id="rId6" imgW="5420042" imgH="2747255" progId="Prism7.Document">
                  <p:embed/>
                  <p:pic>
                    <p:nvPicPr>
                      <p:cNvPr id="16" name="Objekt 1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175313" y="4224469"/>
                        <a:ext cx="3945020" cy="20002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kt 22"/>
          <p:cNvGraphicFramePr>
            <a:graphicFrameLocks noChangeAspect="1"/>
          </p:cNvGraphicFramePr>
          <p:nvPr/>
        </p:nvGraphicFramePr>
        <p:xfrm>
          <a:off x="8046649" y="4224469"/>
          <a:ext cx="3945019" cy="20002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5420042" imgH="2747255" progId="Prism7.Document">
                  <p:embed/>
                </p:oleObj>
              </mc:Choice>
              <mc:Fallback>
                <p:oleObj name="Prism 7" r:id="rId8" imgW="5420042" imgH="2747255" progId="Prism7.Document">
                  <p:embed/>
                  <p:pic>
                    <p:nvPicPr>
                      <p:cNvPr id="23" name="Objekt 2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046649" y="4224469"/>
                        <a:ext cx="3945019" cy="20002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Grafik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05373" y="1806794"/>
            <a:ext cx="3943074" cy="1999106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022205" y="1806792"/>
            <a:ext cx="3943076" cy="1999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9008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A448C0E-F9E6-4A3A-B0AF-FCAD5E4712E6}"/>
              </a:ext>
            </a:extLst>
          </p:cNvPr>
          <p:cNvSpPr txBox="1"/>
          <p:nvPr/>
        </p:nvSpPr>
        <p:spPr>
          <a:xfrm>
            <a:off x="471054" y="516840"/>
            <a:ext cx="11249892" cy="3378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/>
              <a:t>Legend to Suppl. Figure 2a.</a:t>
            </a:r>
            <a:r>
              <a:rPr lang="en-US" sz="1600" dirty="0"/>
              <a:t> Mice were prime-boost immunized intranasally with non-targeted RBD, strain Wuhan-Hu-1 (group #1), or M-cell targeted RBD (RBD-</a:t>
            </a:r>
            <a:r>
              <a:rPr lang="en-US" sz="1600" dirty="0" err="1"/>
              <a:t>cCPE</a:t>
            </a:r>
            <a:r>
              <a:rPr lang="en-US" sz="1600" dirty="0"/>
              <a:t>, group #2), or primed subcutaneously and boosted intranasally with targeted RBD (group #7). All vaccines were adjuvanted with </a:t>
            </a:r>
            <a:r>
              <a:rPr lang="en-US" sz="1600" dirty="0" err="1"/>
              <a:t>Riboxxim</a:t>
            </a:r>
            <a:r>
              <a:rPr lang="en-US" sz="1600" dirty="0"/>
              <a:t>. Control mice (ctrl) were immunized with PBS. Sera, nasal washes and BAL were obtained on day 28, one week after the boost, diluted in 4-fold steps, and assayed for IgG antibodies in Luminex with recombinant RBD, or recombinant trimeric spike protein, both derived from SARS-CoV-2 strain Wuhan-Hu-1. GMT were calculated and compared for groups #1 and #7 for sera, nasal washes and BALF, respectively, to evaluate the effect of targeting the RBD to M-cells on immunogenicity. Mean of control sera (ctrl m) plus 3 standard deviations shown.</a:t>
            </a:r>
          </a:p>
          <a:p>
            <a:pPr algn="just">
              <a:lnSpc>
                <a:spcPct val="150000"/>
              </a:lnSpc>
            </a:pPr>
            <a:endParaRPr lang="en-US" sz="1600" dirty="0"/>
          </a:p>
          <a:p>
            <a:pPr algn="just">
              <a:lnSpc>
                <a:spcPct val="150000"/>
              </a:lnSpc>
            </a:pPr>
            <a:endParaRPr lang="en-US" sz="1600" i="1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853098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3FA2698-B594-3AFA-9745-FE20E2D1A9E5}"/>
              </a:ext>
            </a:extLst>
          </p:cNvPr>
          <p:cNvSpPr txBox="1"/>
          <p:nvPr/>
        </p:nvSpPr>
        <p:spPr>
          <a:xfrm>
            <a:off x="627501" y="218117"/>
            <a:ext cx="101350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. Fig. 2b. M-cell targeting of RBD (RBD-</a:t>
            </a:r>
            <a:r>
              <a:rPr lang="en-US" sz="1800" b="1" dirty="0" err="1"/>
              <a:t>cCPE</a:t>
            </a:r>
            <a:r>
              <a:rPr lang="en-US" sz="1800" b="1" dirty="0"/>
              <a:t>) increases IgG responses in NALF, BALF and serum: Two-way comparison at fixed dilution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B627F00-D566-B9AF-4E6A-1A0B4C0390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458" y="864448"/>
            <a:ext cx="6138144" cy="577543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14215E4-3750-8DA8-45AA-A5BEBDEF6C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2458" y="800705"/>
            <a:ext cx="5959542" cy="59029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8096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4C9952-FCD6-413B-D240-D2F9E126B3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6557" y="261281"/>
            <a:ext cx="11585028" cy="4111022"/>
          </a:xfrm>
        </p:spPr>
        <p:txBody>
          <a:bodyPr>
            <a:noAutofit/>
          </a:bodyPr>
          <a:lstStyle/>
          <a:p>
            <a:pPr marL="0" indent="0">
              <a:lnSpc>
                <a:spcPct val="170000"/>
              </a:lnSpc>
              <a:buNone/>
            </a:pPr>
            <a:r>
              <a:rPr lang="en-US" sz="1600" b="1" dirty="0">
                <a:latin typeface="+mn-lt"/>
              </a:rPr>
              <a:t>Legend to Figure 2b. </a:t>
            </a:r>
            <a:r>
              <a:rPr lang="en-US" sz="1600" dirty="0"/>
              <a:t>Data from Figure 2a were plotted in log-log form the MFI signal was saturated at &gt;10.000 units. For BALF and NALF data points, dilutions 1:20, 1:80, and 1:320 were all saturated, and for serum we saw a similar pattern for dilutions 1:800, 1:3200, and 1:12800. To work within comparable and dynamic ranges of the dilution curves, RBD signals estimated from the 4th dilution points (i.e. the 1:1280 dilution for BALF and NALF; and 1:51200 for Serum) were used for modeling the data. Using “compartment” (NALF, BALF, serum)  and “antigen type” (RBD, RBD-</a:t>
            </a:r>
            <a:r>
              <a:rPr lang="en-US" sz="1600" dirty="0" err="1"/>
              <a:t>cCPE</a:t>
            </a:r>
            <a:r>
              <a:rPr lang="en-US" sz="1600" dirty="0"/>
              <a:t>) as factors, the data were modeled using linear regression. Taking interaction between these two factors into account did not improve the fit in a nested model,  therefore, the interaction term was dropped from the model. Using 0 as the intercept, antigen type RBD-</a:t>
            </a:r>
            <a:r>
              <a:rPr lang="en-US" sz="1600" dirty="0" err="1"/>
              <a:t>cCPE</a:t>
            </a:r>
            <a:r>
              <a:rPr lang="en-US" sz="1600" dirty="0"/>
              <a:t> had the most significant term contributing to the model (p=0.39 for NALF, p=0.032 for BALF, p=0.063 for serum. Two-sided Wilcoxon test for unpaired </a:t>
            </a:r>
            <a:r>
              <a:rPr lang="en-US" sz="1600"/>
              <a:t>samples)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509619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a9d69b0e-97f2-4952-9cee-688392e438b4}" enabled="0" method="" siteId="{a9d69b0e-97f2-4952-9cee-688392e438b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920</TotalTime>
  <Words>442</Words>
  <Application>Microsoft Office PowerPoint</Application>
  <PresentationFormat>Widescreen</PresentationFormat>
  <Paragraphs>11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 ter Meulen</dc:creator>
  <cp:lastModifiedBy>Jan ter Meulen</cp:lastModifiedBy>
  <cp:revision>428</cp:revision>
  <cp:lastPrinted>2022-06-14T19:23:06Z</cp:lastPrinted>
  <dcterms:created xsi:type="dcterms:W3CDTF">2021-11-02T01:47:48Z</dcterms:created>
  <dcterms:modified xsi:type="dcterms:W3CDTF">2023-02-25T23:12:22Z</dcterms:modified>
</cp:coreProperties>
</file>